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81" r:id="rId2"/>
    <p:sldId id="282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0" d="100"/>
          <a:sy n="90" d="100"/>
        </p:scale>
        <p:origin x="264" y="216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AC9-6746-B27B-B59B43FCD87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5AC9-6746-B27B-B59B43FCD87A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AC9-6746-B27B-B59B43FCD87A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1</c:v>
                </c:pt>
                <c:pt idx="1">
                  <c:v>3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C9-6746-B27B-B59B43FCD8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5B6-E740-9137-C27C79473E0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5B6-E740-9137-C27C79473E0A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5B6-E740-9137-C27C79473E0A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3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B6-E740-9137-C27C79473E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F51-BC44-8103-CF6F66C0CC49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1F51-BC44-8103-CF6F66C0CC49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F51-BC44-8103-CF6F66C0CC49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3</c:v>
                </c:pt>
                <c:pt idx="1">
                  <c:v>0.5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51-BC44-8103-CF6F66C0CC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460-3149-8255-C9938CC04113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0460-3149-8255-C9938CC04113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460-3149-8255-C9938CC04113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0.5</c:v>
                </c:pt>
                <c:pt idx="1">
                  <c:v>3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60-3149-8255-C9938CC041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253472222222222"/>
          <c:y val="0.12961720707856547"/>
          <c:w val="0.51493055555555556"/>
          <c:h val="0.740765585842869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9B3-8945-B274-19BB449D3338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79B3-8945-B274-19BB449D3338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9B3-8945-B274-19BB449D3338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2</c:v>
                </c:pt>
                <c:pt idx="1">
                  <c:v>2</c:v>
                </c:pt>
                <c:pt idx="2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B3-8945-B274-19BB449D3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6F4-E24B-AA90-AA4B115FA8FF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96F4-E24B-AA90-AA4B115FA8FF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6F4-E24B-AA90-AA4B115FA8FF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F4-E24B-AA90-AA4B115FA8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D0D-AC42-ABCF-0E30C51CB6A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ED0D-AC42-ABCF-0E30C51CB6AA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D0D-AC42-ABCF-0E30C51CB6AA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0.5</c:v>
                </c:pt>
                <c:pt idx="1">
                  <c:v>1</c:v>
                </c:pt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0D-AC42-ABCF-0E30C51CB6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1F0AE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731-4F4D-9F1F-D413FE0695D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731-4F4D-9F1F-D413FE0695DA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731-4F4D-9F1F-D413FE0695DA}"/>
              </c:ext>
            </c:extLst>
          </c:dPt>
          <c:cat>
            <c:strRef>
              <c:f>Feuil1!$B$2:$D$2</c:f>
              <c:strCache>
                <c:ptCount val="3"/>
                <c:pt idx="0">
                  <c:v>DC/JK</c:v>
                </c:pt>
                <c:pt idx="1">
                  <c:v>DC/JK LPS</c:v>
                </c:pt>
                <c:pt idx="2">
                  <c:v>DC/C91/LPS</c:v>
                </c:pt>
              </c:strCache>
            </c:strRef>
          </c:cat>
          <c:val>
            <c:numRef>
              <c:f>Feuil1!$B$3:$D$3</c:f>
              <c:numCache>
                <c:formatCode>General</c:formatCode>
                <c:ptCount val="3"/>
                <c:pt idx="0">
                  <c:v>2</c:v>
                </c:pt>
                <c:pt idx="1">
                  <c:v>1</c:v>
                </c:pt>
                <c:pt idx="2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31-4F4D-9F1F-D413FE0695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9370720"/>
        <c:axId val="159374048"/>
      </c:barChart>
      <c:catAx>
        <c:axId val="15937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9374048"/>
        <c:crosses val="autoZero"/>
        <c:auto val="1"/>
        <c:lblAlgn val="ctr"/>
        <c:lblOffset val="100"/>
        <c:noMultiLvlLbl val="0"/>
      </c:catAx>
      <c:valAx>
        <c:axId val="15937404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5937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C688EAF-3660-E44E-882C-6BCEE97E6D0C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14081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43B79183-A6F4-A342-A9AC-C9044156A7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5426846"/>
              </p:ext>
            </p:extLst>
          </p:nvPr>
        </p:nvGraphicFramePr>
        <p:xfrm>
          <a:off x="351630" y="1290284"/>
          <a:ext cx="6066103" cy="711114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11968">
                  <a:extLst>
                    <a:ext uri="{9D8B030D-6E8A-4147-A177-3AD203B41FA5}">
                      <a16:colId xmlns:a16="http://schemas.microsoft.com/office/drawing/2014/main" val="2628962122"/>
                    </a:ext>
                  </a:extLst>
                </a:gridCol>
                <a:gridCol w="1076178">
                  <a:extLst>
                    <a:ext uri="{9D8B030D-6E8A-4147-A177-3AD203B41FA5}">
                      <a16:colId xmlns:a16="http://schemas.microsoft.com/office/drawing/2014/main" val="3913879344"/>
                    </a:ext>
                  </a:extLst>
                </a:gridCol>
                <a:gridCol w="956603">
                  <a:extLst>
                    <a:ext uri="{9D8B030D-6E8A-4147-A177-3AD203B41FA5}">
                      <a16:colId xmlns:a16="http://schemas.microsoft.com/office/drawing/2014/main" val="425118948"/>
                    </a:ext>
                  </a:extLst>
                </a:gridCol>
                <a:gridCol w="928468">
                  <a:extLst>
                    <a:ext uri="{9D8B030D-6E8A-4147-A177-3AD203B41FA5}">
                      <a16:colId xmlns:a16="http://schemas.microsoft.com/office/drawing/2014/main" val="1115299993"/>
                    </a:ext>
                  </a:extLst>
                </a:gridCol>
                <a:gridCol w="1892886">
                  <a:extLst>
                    <a:ext uri="{9D8B030D-6E8A-4147-A177-3AD203B41FA5}">
                      <a16:colId xmlns:a16="http://schemas.microsoft.com/office/drawing/2014/main" val="205552602"/>
                    </a:ext>
                  </a:extLst>
                </a:gridCol>
              </a:tblGrid>
              <a:tr h="284267">
                <a:tc row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patter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teri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5753743"/>
                  </a:ext>
                </a:extLst>
              </a:tr>
              <a:tr h="706330">
                <a:tc vMerge="1"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CC9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rkat</a:t>
                      </a: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tim. w/ </a:t>
                      </a:r>
                      <a:r>
                        <a:rPr lang="fr-FR" sz="8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</a:t>
                      </a:r>
                    </a:p>
                    <a:p>
                      <a:pPr algn="ctr"/>
                      <a:r>
                        <a:rPr lang="fr-FR" sz="8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CC9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rkat</a:t>
                      </a:r>
                      <a:endParaRPr lang="fr-FR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00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91-PL</a:t>
                      </a: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tim. w/ </a:t>
                      </a:r>
                      <a:r>
                        <a:rPr lang="fr-FR" sz="8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</a:t>
                      </a:r>
                    </a:p>
                    <a:p>
                      <a:pPr algn="ctr"/>
                      <a:r>
                        <a:rPr lang="fr-FR" sz="8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CC9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rkat</a:t>
                      </a: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tim. w/ </a:t>
                      </a:r>
                      <a:r>
                        <a:rPr lang="fr-FR" sz="8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00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91-PL</a:t>
                      </a:r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tim. w/ </a:t>
                      </a:r>
                      <a:r>
                        <a:rPr lang="fr-FR" sz="8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</a:t>
                      </a:r>
                    </a:p>
                    <a:p>
                      <a:pPr algn="ctr"/>
                      <a:r>
                        <a:rPr lang="fr-FR" sz="8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</a:p>
                    <a:p>
                      <a:pPr algn="ctr"/>
                      <a:r>
                        <a:rPr lang="fr-FR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DC/</a:t>
                      </a:r>
                      <a:r>
                        <a:rPr lang="fr-FR" sz="800" b="1" dirty="0">
                          <a:solidFill>
                            <a:srgbClr val="00CC9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rkat</a:t>
                      </a:r>
                      <a:endParaRPr lang="fr-FR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7287872"/>
                  </a:ext>
                </a:extLst>
              </a:tr>
              <a:tr h="765068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Responsiveness </a:t>
                      </a:r>
                      <a:r>
                        <a:rPr lang="en-US" sz="800" b="1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ferred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 pre-exposure to infected cells</a:t>
                      </a:r>
                    </a:p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e it induction, top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repression, bottom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significa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</a:t>
                      </a:r>
                    </a:p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</a:t>
                      </a:r>
                    </a:p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43807"/>
                  </a:ext>
                </a:extLst>
              </a:tr>
              <a:tr h="76506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significa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</a:t>
                      </a:r>
                    </a:p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</a:t>
                      </a:r>
                    </a:p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8051698"/>
                  </a:ext>
                </a:extLst>
              </a:tr>
              <a:tr h="765068"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i) Responsiveness </a:t>
                      </a:r>
                      <a:r>
                        <a:rPr lang="en-US" sz="800" b="1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acerbated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 pre-exposure to infected cells</a:t>
                      </a:r>
                    </a:p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e it induction, top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repression, bottom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688656"/>
                  </a:ext>
                </a:extLst>
              </a:tr>
              <a:tr h="76506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6517868"/>
                  </a:ext>
                </a:extLst>
              </a:tr>
              <a:tr h="765068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ii) Responsiveness </a:t>
                      </a:r>
                      <a:r>
                        <a:rPr lang="en-US" sz="800" b="1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enuated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 pre-exposure to infected cell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e it induction, top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repression, bottom)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888235"/>
                  </a:ext>
                </a:extLst>
              </a:tr>
              <a:tr h="76506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2373404"/>
                  </a:ext>
                </a:extLst>
              </a:tr>
              <a:tr h="765068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v) Responsiveness </a:t>
                      </a:r>
                      <a:r>
                        <a:rPr lang="en-US" sz="800" b="1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lished</a:t>
                      </a: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 pre-exposure to infected cell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e it induction, top</a:t>
                      </a:r>
                    </a:p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repression, bottom)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significa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292775"/>
                  </a:ext>
                </a:extLst>
              </a:tr>
              <a:tr h="765068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dow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 (u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significa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511342"/>
                  </a:ext>
                </a:extLst>
              </a:tr>
            </a:tbl>
          </a:graphicData>
        </a:graphic>
      </p:graphicFrame>
      <p:graphicFrame>
        <p:nvGraphicFramePr>
          <p:cNvPr id="33" name="Graphique 32">
            <a:extLst>
              <a:ext uri="{FF2B5EF4-FFF2-40B4-BE49-F238E27FC236}">
                <a16:creationId xmlns:a16="http://schemas.microsoft.com/office/drawing/2014/main" id="{61D4B441-7FCE-1B4E-ACE9-78B8E0FE16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6369050"/>
              </p:ext>
            </p:extLst>
          </p:nvPr>
        </p:nvGraphicFramePr>
        <p:xfrm>
          <a:off x="5029003" y="6589273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4" name="Graphique 33">
            <a:extLst>
              <a:ext uri="{FF2B5EF4-FFF2-40B4-BE49-F238E27FC236}">
                <a16:creationId xmlns:a16="http://schemas.microsoft.com/office/drawing/2014/main" id="{F699F005-9456-9D4B-A30E-31378169BD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1828261"/>
              </p:ext>
            </p:extLst>
          </p:nvPr>
        </p:nvGraphicFramePr>
        <p:xfrm>
          <a:off x="5029003" y="7383863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Graphique 31">
            <a:extLst>
              <a:ext uri="{FF2B5EF4-FFF2-40B4-BE49-F238E27FC236}">
                <a16:creationId xmlns:a16="http://schemas.microsoft.com/office/drawing/2014/main" id="{12B1BF13-3027-104F-A3A2-815CE2B93C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32831"/>
              </p:ext>
            </p:extLst>
          </p:nvPr>
        </p:nvGraphicFramePr>
        <p:xfrm>
          <a:off x="5029003" y="5826103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1" name="Graphique 30">
            <a:extLst>
              <a:ext uri="{FF2B5EF4-FFF2-40B4-BE49-F238E27FC236}">
                <a16:creationId xmlns:a16="http://schemas.microsoft.com/office/drawing/2014/main" id="{21526D85-9048-614F-B60D-693562D880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5848103"/>
              </p:ext>
            </p:extLst>
          </p:nvPr>
        </p:nvGraphicFramePr>
        <p:xfrm>
          <a:off x="5029003" y="5046224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63E103F8-59EA-874F-A588-1F2BAAD99743}"/>
              </a:ext>
            </a:extLst>
          </p:cNvPr>
          <p:cNvSpPr txBox="1"/>
          <p:nvPr/>
        </p:nvSpPr>
        <p:spPr>
          <a:xfrm>
            <a:off x="2461619" y="330902"/>
            <a:ext cx="222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7</a:t>
            </a:r>
          </a:p>
        </p:txBody>
      </p:sp>
      <p:graphicFrame>
        <p:nvGraphicFramePr>
          <p:cNvPr id="62" name="Graphique 61">
            <a:extLst>
              <a:ext uri="{FF2B5EF4-FFF2-40B4-BE49-F238E27FC236}">
                <a16:creationId xmlns:a16="http://schemas.microsoft.com/office/drawing/2014/main" id="{B10A382E-D8FB-0C41-9FC5-4B06574E96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4285775"/>
              </p:ext>
            </p:extLst>
          </p:nvPr>
        </p:nvGraphicFramePr>
        <p:xfrm>
          <a:off x="5029003" y="2703428"/>
          <a:ext cx="576000" cy="1077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3" name="Graphique 62">
            <a:extLst>
              <a:ext uri="{FF2B5EF4-FFF2-40B4-BE49-F238E27FC236}">
                <a16:creationId xmlns:a16="http://schemas.microsoft.com/office/drawing/2014/main" id="{F921A221-5CB8-B741-A7B5-F07CAE0D48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3125880"/>
              </p:ext>
            </p:extLst>
          </p:nvPr>
        </p:nvGraphicFramePr>
        <p:xfrm>
          <a:off x="5029003" y="2001778"/>
          <a:ext cx="576000" cy="1077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64" name="Groupe 63">
            <a:extLst>
              <a:ext uri="{FF2B5EF4-FFF2-40B4-BE49-F238E27FC236}">
                <a16:creationId xmlns:a16="http://schemas.microsoft.com/office/drawing/2014/main" id="{CCB6B73D-D2C2-0F47-8AB2-B73ED0B16973}"/>
              </a:ext>
            </a:extLst>
          </p:cNvPr>
          <p:cNvGrpSpPr/>
          <p:nvPr/>
        </p:nvGrpSpPr>
        <p:grpSpPr>
          <a:xfrm>
            <a:off x="4768022" y="1540685"/>
            <a:ext cx="1511024" cy="523531"/>
            <a:chOff x="5250884" y="4003870"/>
            <a:chExt cx="1511024" cy="523531"/>
          </a:xfrm>
        </p:grpSpPr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93B869CF-E27C-3943-9EA7-BA7C539CBE32}"/>
                </a:ext>
              </a:extLst>
            </p:cNvPr>
            <p:cNvSpPr txBox="1"/>
            <p:nvPr/>
          </p:nvSpPr>
          <p:spPr>
            <a:xfrm>
              <a:off x="5364590" y="4327346"/>
              <a:ext cx="1397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91-PL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 restim. w/ </a:t>
              </a:r>
              <a:r>
                <a:rPr lang="fr-FR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78BF8081-ABF2-DA47-B8C7-B04447212251}"/>
                </a:ext>
              </a:extLst>
            </p:cNvPr>
            <p:cNvSpPr txBox="1"/>
            <p:nvPr/>
          </p:nvSpPr>
          <p:spPr>
            <a:xfrm>
              <a:off x="5364590" y="4166562"/>
              <a:ext cx="13548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 restim. w/ </a:t>
              </a:r>
              <a:r>
                <a:rPr lang="fr-FR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 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A420FEFE-FD0A-BA4E-9096-8FB8589C3426}"/>
                </a:ext>
              </a:extLst>
            </p:cNvPr>
            <p:cNvSpPr txBox="1"/>
            <p:nvPr/>
          </p:nvSpPr>
          <p:spPr>
            <a:xfrm>
              <a:off x="5364590" y="4003870"/>
              <a:ext cx="7232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FA678441-AA31-D344-9B10-FB1A9597BFDD}"/>
                </a:ext>
              </a:extLst>
            </p:cNvPr>
            <p:cNvSpPr/>
            <p:nvPr/>
          </p:nvSpPr>
          <p:spPr>
            <a:xfrm>
              <a:off x="5250884" y="4076093"/>
              <a:ext cx="118098" cy="59372"/>
            </a:xfrm>
            <a:prstGeom prst="rect">
              <a:avLst/>
            </a:prstGeom>
            <a:solidFill>
              <a:srgbClr val="41F0AE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8065FA2-F0BD-B647-9E50-7A9A7EA58098}"/>
                </a:ext>
              </a:extLst>
            </p:cNvPr>
            <p:cNvSpPr/>
            <p:nvPr/>
          </p:nvSpPr>
          <p:spPr>
            <a:xfrm>
              <a:off x="5250884" y="4228493"/>
              <a:ext cx="118098" cy="593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A09DD454-85BB-A749-9A20-E2520B1D069E}"/>
                </a:ext>
              </a:extLst>
            </p:cNvPr>
            <p:cNvSpPr/>
            <p:nvPr/>
          </p:nvSpPr>
          <p:spPr>
            <a:xfrm>
              <a:off x="5250884" y="4389946"/>
              <a:ext cx="118098" cy="5937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9" name="Graphique 28">
            <a:extLst>
              <a:ext uri="{FF2B5EF4-FFF2-40B4-BE49-F238E27FC236}">
                <a16:creationId xmlns:a16="http://schemas.microsoft.com/office/drawing/2014/main" id="{EA7962D2-0961-1644-A3FD-82D93C52EF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2291917"/>
              </p:ext>
            </p:extLst>
          </p:nvPr>
        </p:nvGraphicFramePr>
        <p:xfrm>
          <a:off x="5029003" y="3542616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0" name="Graphique 29">
            <a:extLst>
              <a:ext uri="{FF2B5EF4-FFF2-40B4-BE49-F238E27FC236}">
                <a16:creationId xmlns:a16="http://schemas.microsoft.com/office/drawing/2014/main" id="{61C7DFB4-56EE-4A49-B5E6-FFD3EB0D7D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5842624"/>
              </p:ext>
            </p:extLst>
          </p:nvPr>
        </p:nvGraphicFramePr>
        <p:xfrm>
          <a:off x="5029003" y="4283054"/>
          <a:ext cx="577181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35" name="ZoneTexte 34">
            <a:extLst>
              <a:ext uri="{FF2B5EF4-FFF2-40B4-BE49-F238E27FC236}">
                <a16:creationId xmlns:a16="http://schemas.microsoft.com/office/drawing/2014/main" id="{DB301E21-B33A-EA44-9CF9-5160E61A9676}"/>
              </a:ext>
            </a:extLst>
          </p:cNvPr>
          <p:cNvSpPr txBox="1"/>
          <p:nvPr/>
        </p:nvSpPr>
        <p:spPr>
          <a:xfrm>
            <a:off x="226478" y="891465"/>
            <a:ext cx="155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B533428-1EE5-C151-3C8C-B38F28840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97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B1493770-1121-C64C-AAB4-D5E9D8BFA02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47734" y="2766257"/>
            <a:ext cx="897949" cy="936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C23E0BF6-481E-B744-8215-F41FF9E39747}"/>
              </a:ext>
            </a:extLst>
          </p:cNvPr>
          <p:cNvSpPr txBox="1"/>
          <p:nvPr/>
        </p:nvSpPr>
        <p:spPr>
          <a:xfrm>
            <a:off x="4362532" y="365393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SG15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42593A54-CD5C-1248-A2C1-BA0F2FE31496}"/>
              </a:ext>
            </a:extLst>
          </p:cNvPr>
          <p:cNvSpPr txBox="1"/>
          <p:nvPr/>
        </p:nvSpPr>
        <p:spPr>
          <a:xfrm rot="16200000">
            <a:off x="3328777" y="3102054"/>
            <a:ext cx="1083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ormalized gene expression</a:t>
            </a: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F192EADA-8DA6-3E41-8613-752E429A52E9}"/>
              </a:ext>
            </a:extLst>
          </p:cNvPr>
          <p:cNvGrpSpPr/>
          <p:nvPr/>
        </p:nvGrpSpPr>
        <p:grpSpPr>
          <a:xfrm>
            <a:off x="5152374" y="943276"/>
            <a:ext cx="1511024" cy="666728"/>
            <a:chOff x="5250884" y="4003870"/>
            <a:chExt cx="1511024" cy="666728"/>
          </a:xfrm>
        </p:grpSpPr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8FE4DA78-BFCC-8F40-A948-D1F80F550D90}"/>
                </a:ext>
              </a:extLst>
            </p:cNvPr>
            <p:cNvSpPr txBox="1"/>
            <p:nvPr/>
          </p:nvSpPr>
          <p:spPr>
            <a:xfrm>
              <a:off x="5364590" y="4327346"/>
              <a:ext cx="13973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91-PL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 restim. w/ </a:t>
              </a:r>
              <a:r>
                <a:rPr lang="fr-FR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A5B70DED-DB85-084A-AEB4-F731D3471792}"/>
                </a:ext>
              </a:extLst>
            </p:cNvPr>
            <p:cNvSpPr txBox="1"/>
            <p:nvPr/>
          </p:nvSpPr>
          <p:spPr>
            <a:xfrm>
              <a:off x="5364590" y="4166562"/>
              <a:ext cx="13548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 restim. w/ </a:t>
              </a:r>
              <a:r>
                <a:rPr lang="fr-FR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 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95348420-B979-2C49-A739-F6E15B053D8F}"/>
                </a:ext>
              </a:extLst>
            </p:cNvPr>
            <p:cNvSpPr txBox="1"/>
            <p:nvPr/>
          </p:nvSpPr>
          <p:spPr>
            <a:xfrm>
              <a:off x="5364590" y="4470543"/>
              <a:ext cx="135485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800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8166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 restim. w/ </a:t>
              </a:r>
              <a:r>
                <a:rPr lang="fr-FR" sz="7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158495E-929A-EE4F-AA37-B0B89E56BBD7}"/>
                </a:ext>
              </a:extLst>
            </p:cNvPr>
            <p:cNvSpPr txBox="1"/>
            <p:nvPr/>
          </p:nvSpPr>
          <p:spPr>
            <a:xfrm>
              <a:off x="5364590" y="4003870"/>
              <a:ext cx="7232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700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CDA8E1D-18A8-E14D-8CB1-2AEB106F703D}"/>
                </a:ext>
              </a:extLst>
            </p:cNvPr>
            <p:cNvSpPr/>
            <p:nvPr/>
          </p:nvSpPr>
          <p:spPr>
            <a:xfrm>
              <a:off x="5250884" y="4076093"/>
              <a:ext cx="118098" cy="59372"/>
            </a:xfrm>
            <a:prstGeom prst="rect">
              <a:avLst/>
            </a:prstGeom>
            <a:solidFill>
              <a:srgbClr val="41F0AE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C715E23-0200-EC42-888A-5A0E5B27C253}"/>
                </a:ext>
              </a:extLst>
            </p:cNvPr>
            <p:cNvSpPr/>
            <p:nvPr/>
          </p:nvSpPr>
          <p:spPr>
            <a:xfrm>
              <a:off x="5250884" y="4228493"/>
              <a:ext cx="118098" cy="5937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D83AD25-C484-214E-B4CE-C46E8DA993A9}"/>
                </a:ext>
              </a:extLst>
            </p:cNvPr>
            <p:cNvSpPr/>
            <p:nvPr/>
          </p:nvSpPr>
          <p:spPr>
            <a:xfrm>
              <a:off x="5250884" y="4389946"/>
              <a:ext cx="118098" cy="5937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6F04FA2B-75C9-4E4F-B2A1-C6BDAB6645CC}"/>
                </a:ext>
              </a:extLst>
            </p:cNvPr>
            <p:cNvSpPr/>
            <p:nvPr/>
          </p:nvSpPr>
          <p:spPr>
            <a:xfrm>
              <a:off x="5250884" y="4542346"/>
              <a:ext cx="118098" cy="59372"/>
            </a:xfrm>
            <a:prstGeom prst="rect">
              <a:avLst/>
            </a:prstGeom>
            <a:solidFill>
              <a:srgbClr val="80008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6A7BAF54-F529-0D47-8962-9E4436F9FA81}"/>
              </a:ext>
            </a:extLst>
          </p:cNvPr>
          <p:cNvGrpSpPr/>
          <p:nvPr/>
        </p:nvGrpSpPr>
        <p:grpSpPr>
          <a:xfrm>
            <a:off x="371532" y="2289643"/>
            <a:ext cx="3133426" cy="1649714"/>
            <a:chOff x="168785" y="3581400"/>
            <a:chExt cx="2957216" cy="1649714"/>
          </a:xfrm>
        </p:grpSpPr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E47D3A3A-C366-0F48-89AD-D06549A09364}"/>
                </a:ext>
              </a:extLst>
            </p:cNvPr>
            <p:cNvGrpSpPr/>
            <p:nvPr/>
          </p:nvGrpSpPr>
          <p:grpSpPr>
            <a:xfrm>
              <a:off x="699261" y="4121043"/>
              <a:ext cx="790351" cy="1091227"/>
              <a:chOff x="5774989" y="4101455"/>
              <a:chExt cx="790351" cy="1091227"/>
            </a:xfrm>
          </p:grpSpPr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AD27652C-2045-074E-8317-040E84AB32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5774989" y="4101455"/>
                <a:ext cx="790351" cy="936000"/>
              </a:xfrm>
              <a:prstGeom prst="rect">
                <a:avLst/>
              </a:prstGeom>
            </p:spPr>
          </p:pic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DC70E45E-9159-A848-B50C-7045D0957E31}"/>
                  </a:ext>
                </a:extLst>
              </p:cNvPr>
              <p:cNvSpPr txBox="1"/>
              <p:nvPr/>
            </p:nvSpPr>
            <p:spPr>
              <a:xfrm>
                <a:off x="5996952" y="4977238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BMP6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" name="Groupe 15">
              <a:extLst>
                <a:ext uri="{FF2B5EF4-FFF2-40B4-BE49-F238E27FC236}">
                  <a16:creationId xmlns:a16="http://schemas.microsoft.com/office/drawing/2014/main" id="{9FCE5A97-0C02-DA42-AA74-CEFDBA60DCB1}"/>
                </a:ext>
              </a:extLst>
            </p:cNvPr>
            <p:cNvGrpSpPr/>
            <p:nvPr/>
          </p:nvGrpSpPr>
          <p:grpSpPr>
            <a:xfrm>
              <a:off x="1436214" y="4121043"/>
              <a:ext cx="760034" cy="1058501"/>
              <a:chOff x="4721897" y="5503890"/>
              <a:chExt cx="760034" cy="1058501"/>
            </a:xfrm>
          </p:grpSpPr>
          <p:pic>
            <p:nvPicPr>
              <p:cNvPr id="23" name="Image 22">
                <a:extLst>
                  <a:ext uri="{FF2B5EF4-FFF2-40B4-BE49-F238E27FC236}">
                    <a16:creationId xmlns:a16="http://schemas.microsoft.com/office/drawing/2014/main" id="{A34ABA8F-C51F-A143-9F02-2B49F79528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4721897" y="5503890"/>
                <a:ext cx="760034" cy="936000"/>
              </a:xfrm>
              <a:prstGeom prst="rect">
                <a:avLst/>
              </a:prstGeom>
            </p:spPr>
          </p:pic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3E4560CA-DB95-7343-ABDA-A367AAEDEAD7}"/>
                  </a:ext>
                </a:extLst>
              </p:cNvPr>
              <p:cNvSpPr txBox="1"/>
              <p:nvPr/>
            </p:nvSpPr>
            <p:spPr>
              <a:xfrm>
                <a:off x="4942855" y="6346947"/>
                <a:ext cx="4651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BMP7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A32F0EAD-AB79-7749-8E5D-EDF845A70092}"/>
                </a:ext>
              </a:extLst>
            </p:cNvPr>
            <p:cNvSpPr txBox="1"/>
            <p:nvPr/>
          </p:nvSpPr>
          <p:spPr>
            <a:xfrm rot="16200000">
              <a:off x="-45852" y="4376301"/>
              <a:ext cx="10834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ormalized gene expression</a:t>
              </a:r>
            </a:p>
          </p:txBody>
        </p:sp>
        <p:grpSp>
          <p:nvGrpSpPr>
            <p:cNvPr id="18" name="Groupe 17">
              <a:extLst>
                <a:ext uri="{FF2B5EF4-FFF2-40B4-BE49-F238E27FC236}">
                  <a16:creationId xmlns:a16="http://schemas.microsoft.com/office/drawing/2014/main" id="{8AC86F9C-392A-3B4D-8FE4-BAB1ABCA0A1C}"/>
                </a:ext>
              </a:extLst>
            </p:cNvPr>
            <p:cNvGrpSpPr/>
            <p:nvPr/>
          </p:nvGrpSpPr>
          <p:grpSpPr>
            <a:xfrm>
              <a:off x="2223375" y="4097710"/>
              <a:ext cx="781583" cy="1077460"/>
              <a:chOff x="5822765" y="5520062"/>
              <a:chExt cx="781583" cy="1077460"/>
            </a:xfrm>
          </p:grpSpPr>
          <p:pic>
            <p:nvPicPr>
              <p:cNvPr id="21" name="Image 20">
                <a:extLst>
                  <a:ext uri="{FF2B5EF4-FFF2-40B4-BE49-F238E27FC236}">
                    <a16:creationId xmlns:a16="http://schemas.microsoft.com/office/drawing/2014/main" id="{85B37190-F85B-1D4F-B842-178F0633AA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5822765" y="5520062"/>
                <a:ext cx="781583" cy="936000"/>
              </a:xfrm>
              <a:prstGeom prst="rect">
                <a:avLst/>
              </a:prstGeom>
            </p:spPr>
          </p:pic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01D77F1C-423E-B04F-8637-911023D059C2}"/>
                  </a:ext>
                </a:extLst>
              </p:cNvPr>
              <p:cNvSpPr txBox="1"/>
              <p:nvPr/>
            </p:nvSpPr>
            <p:spPr>
              <a:xfrm>
                <a:off x="6086354" y="6382078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L13</a:t>
                </a:r>
                <a:endParaRPr kumimoji="0" lang="fr-F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47588176-14A4-5041-9527-1A29FF30336A}"/>
                </a:ext>
              </a:extLst>
            </p:cNvPr>
            <p:cNvSpPr txBox="1"/>
            <p:nvPr/>
          </p:nvSpPr>
          <p:spPr>
            <a:xfrm>
              <a:off x="856475" y="3636655"/>
              <a:ext cx="17472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sponsiveness </a:t>
              </a:r>
              <a:r>
                <a:rPr lang="en-US" sz="8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conferred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y pre-exposure to infected cells</a:t>
              </a:r>
            </a:p>
          </p:txBody>
        </p:sp>
        <p:sp>
          <p:nvSpPr>
            <p:cNvPr id="20" name="Rectangle à coins arrondis 19">
              <a:extLst>
                <a:ext uri="{FF2B5EF4-FFF2-40B4-BE49-F238E27FC236}">
                  <a16:creationId xmlns:a16="http://schemas.microsoft.com/office/drawing/2014/main" id="{B3EE9BB5-6361-7A41-831F-52D7BC8DF4A2}"/>
                </a:ext>
              </a:extLst>
            </p:cNvPr>
            <p:cNvSpPr/>
            <p:nvPr/>
          </p:nvSpPr>
          <p:spPr>
            <a:xfrm>
              <a:off x="168785" y="3581400"/>
              <a:ext cx="2957216" cy="1649714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7" name="Rectangle à coins arrondis 26">
            <a:extLst>
              <a:ext uri="{FF2B5EF4-FFF2-40B4-BE49-F238E27FC236}">
                <a16:creationId xmlns:a16="http://schemas.microsoft.com/office/drawing/2014/main" id="{6A577D3D-739B-4B43-8F4F-C3A117FC28B9}"/>
              </a:ext>
            </a:extLst>
          </p:cNvPr>
          <p:cNvSpPr/>
          <p:nvPr/>
        </p:nvSpPr>
        <p:spPr>
          <a:xfrm>
            <a:off x="3640078" y="2270315"/>
            <a:ext cx="3122722" cy="1657406"/>
          </a:xfrm>
          <a:prstGeom prst="round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61E330B3-9F58-F848-B782-43C47AC978EC}"/>
              </a:ext>
            </a:extLst>
          </p:cNvPr>
          <p:cNvGrpSpPr/>
          <p:nvPr/>
        </p:nvGrpSpPr>
        <p:grpSpPr>
          <a:xfrm>
            <a:off x="371532" y="504899"/>
            <a:ext cx="4674350" cy="1635033"/>
            <a:chOff x="149203" y="5516957"/>
            <a:chExt cx="4674350" cy="1635033"/>
          </a:xfrm>
        </p:grpSpPr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6084B20C-BD0B-AB4B-926A-03329806B1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69985" y="6005711"/>
              <a:ext cx="806097" cy="936000"/>
            </a:xfrm>
            <a:prstGeom prst="rect">
              <a:avLst/>
            </a:prstGeom>
          </p:spPr>
        </p:pic>
        <p:pic>
          <p:nvPicPr>
            <p:cNvPr id="30" name="Image 29">
              <a:extLst>
                <a:ext uri="{FF2B5EF4-FFF2-40B4-BE49-F238E27FC236}">
                  <a16:creationId xmlns:a16="http://schemas.microsoft.com/office/drawing/2014/main" id="{6B10C180-81FE-2C47-A5E9-4DB5B12F50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981657" y="6005711"/>
              <a:ext cx="907477" cy="936000"/>
            </a:xfrm>
            <a:prstGeom prst="rect">
              <a:avLst/>
            </a:prstGeom>
          </p:spPr>
        </p:pic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D9A0B98B-0A59-FA48-A820-86BEC08A08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813387" y="6005711"/>
              <a:ext cx="907477" cy="936000"/>
            </a:xfrm>
            <a:prstGeom prst="rect">
              <a:avLst/>
            </a:prstGeom>
          </p:spPr>
        </p:pic>
        <p:pic>
          <p:nvPicPr>
            <p:cNvPr id="32" name="Image 31">
              <a:extLst>
                <a:ext uri="{FF2B5EF4-FFF2-40B4-BE49-F238E27FC236}">
                  <a16:creationId xmlns:a16="http://schemas.microsoft.com/office/drawing/2014/main" id="{F8E45AA1-CDAC-8643-8613-FC2C3EF0E0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68589" y="6005711"/>
              <a:ext cx="806097" cy="936000"/>
            </a:xfrm>
            <a:prstGeom prst="rect">
              <a:avLst/>
            </a:prstGeom>
          </p:spPr>
        </p:pic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id="{42B9458D-84B2-5E4A-8865-3897133365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186248" y="6005711"/>
              <a:ext cx="806097" cy="936000"/>
            </a:xfrm>
            <a:prstGeom prst="rect">
              <a:avLst/>
            </a:prstGeom>
          </p:spPr>
        </p:pic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A2D7E64-179D-D742-A1B4-64A402B03385}"/>
                </a:ext>
              </a:extLst>
            </p:cNvPr>
            <p:cNvSpPr txBox="1"/>
            <p:nvPr/>
          </p:nvSpPr>
          <p:spPr>
            <a:xfrm>
              <a:off x="803443" y="6898831"/>
              <a:ext cx="585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CL2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53ABA7E6-1996-5E40-87AD-152C64617B55}"/>
                </a:ext>
              </a:extLst>
            </p:cNvPr>
            <p:cNvSpPr txBox="1"/>
            <p:nvPr/>
          </p:nvSpPr>
          <p:spPr>
            <a:xfrm>
              <a:off x="1589036" y="6899325"/>
              <a:ext cx="585066" cy="214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L12B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7BA92A41-ED55-3B4A-8941-DB449D8ADFAE}"/>
                </a:ext>
              </a:extLst>
            </p:cNvPr>
            <p:cNvSpPr txBox="1"/>
            <p:nvPr/>
          </p:nvSpPr>
          <p:spPr>
            <a:xfrm>
              <a:off x="2400857" y="6899325"/>
              <a:ext cx="585066" cy="214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C44BDB90-6629-A245-8C8E-10F4B04F484F}"/>
                </a:ext>
              </a:extLst>
            </p:cNvPr>
            <p:cNvSpPr txBox="1"/>
            <p:nvPr/>
          </p:nvSpPr>
          <p:spPr>
            <a:xfrm>
              <a:off x="3293679" y="6898831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XCL10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E7AA8758-229E-3247-852E-2FFEFD29D169}"/>
                </a:ext>
              </a:extLst>
            </p:cNvPr>
            <p:cNvSpPr txBox="1"/>
            <p:nvPr/>
          </p:nvSpPr>
          <p:spPr>
            <a:xfrm>
              <a:off x="4098765" y="6898831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XCL11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18FB87EC-A144-964A-82BF-A69F92677874}"/>
                </a:ext>
              </a:extLst>
            </p:cNvPr>
            <p:cNvSpPr txBox="1"/>
            <p:nvPr/>
          </p:nvSpPr>
          <p:spPr>
            <a:xfrm rot="16200000">
              <a:off x="-132630" y="6310683"/>
              <a:ext cx="10834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gene expression</a:t>
              </a:r>
            </a:p>
          </p:txBody>
        </p:sp>
        <p:sp>
          <p:nvSpPr>
            <p:cNvPr id="40" name="Rectangle à coins arrondis 39">
              <a:extLst>
                <a:ext uri="{FF2B5EF4-FFF2-40B4-BE49-F238E27FC236}">
                  <a16:creationId xmlns:a16="http://schemas.microsoft.com/office/drawing/2014/main" id="{FA10C68B-23C4-124E-84FB-4EAD14D95A44}"/>
                </a:ext>
              </a:extLst>
            </p:cNvPr>
            <p:cNvSpPr/>
            <p:nvPr/>
          </p:nvSpPr>
          <p:spPr>
            <a:xfrm>
              <a:off x="149203" y="5516957"/>
              <a:ext cx="4674350" cy="1635033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7C9615A8-CAE3-AF4D-93C0-BB4BCA41ED58}"/>
                </a:ext>
              </a:extLst>
            </p:cNvPr>
            <p:cNvSpPr txBox="1"/>
            <p:nvPr/>
          </p:nvSpPr>
          <p:spPr>
            <a:xfrm>
              <a:off x="1442681" y="5553806"/>
              <a:ext cx="21420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Responsiveness </a:t>
              </a:r>
              <a:r>
                <a:rPr lang="en-US" sz="800" b="1" u="sng">
                  <a:latin typeface="Arial" panose="020B0604020202020204" pitchFamily="34" charset="0"/>
                  <a:cs typeface="Arial" panose="020B0604020202020204" pitchFamily="34" charset="0"/>
                </a:rPr>
                <a:t>attenuated</a:t>
              </a:r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 or </a:t>
              </a:r>
              <a:r>
                <a:rPr lang="en-US" sz="800" b="1" u="sng">
                  <a:latin typeface="Arial" panose="020B0604020202020204" pitchFamily="34" charset="0"/>
                  <a:cs typeface="Arial" panose="020B0604020202020204" pitchFamily="34" charset="0"/>
                </a:rPr>
                <a:t>abolished</a:t>
              </a:r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 by pre-exposure to infected cells</a:t>
              </a:r>
            </a:p>
          </p:txBody>
        </p:sp>
      </p:grpSp>
      <p:sp>
        <p:nvSpPr>
          <p:cNvPr id="42" name="ZoneTexte 41">
            <a:extLst>
              <a:ext uri="{FF2B5EF4-FFF2-40B4-BE49-F238E27FC236}">
                <a16:creationId xmlns:a16="http://schemas.microsoft.com/office/drawing/2014/main" id="{9A57DC87-A8C6-7B4D-A629-9FD0FE775758}"/>
              </a:ext>
            </a:extLst>
          </p:cNvPr>
          <p:cNvSpPr txBox="1"/>
          <p:nvPr/>
        </p:nvSpPr>
        <p:spPr>
          <a:xfrm>
            <a:off x="4295859" y="2331998"/>
            <a:ext cx="17472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sponsiveness </a:t>
            </a:r>
            <a:r>
              <a:rPr lang="en-US" sz="800" b="1" u="sng" dirty="0">
                <a:latin typeface="Arial" panose="020B0604020202020204" pitchFamily="34" charset="0"/>
                <a:cs typeface="Arial" panose="020B0604020202020204" pitchFamily="34" charset="0"/>
              </a:rPr>
              <a:t>unaffecte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y pre-exposure to infected cells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A53DEB44-0EF2-FB4D-856F-11C2678B8A07}"/>
              </a:ext>
            </a:extLst>
          </p:cNvPr>
          <p:cNvSpPr txBox="1"/>
          <p:nvPr/>
        </p:nvSpPr>
        <p:spPr>
          <a:xfrm>
            <a:off x="226478" y="77550"/>
            <a:ext cx="155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AD08A57E-16D3-557E-57C8-3180908BC6F8}"/>
              </a:ext>
            </a:extLst>
          </p:cNvPr>
          <p:cNvSpPr txBox="1"/>
          <p:nvPr/>
        </p:nvSpPr>
        <p:spPr>
          <a:xfrm>
            <a:off x="5201439" y="3653934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FI44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40EC2224-1332-740D-3ACC-697153FB46FE}"/>
              </a:ext>
            </a:extLst>
          </p:cNvPr>
          <p:cNvSpPr txBox="1"/>
          <p:nvPr/>
        </p:nvSpPr>
        <p:spPr>
          <a:xfrm>
            <a:off x="6099109" y="3653934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RF2</a:t>
            </a:r>
            <a:endParaRPr kumimoji="0" lang="fr-F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50" name="Image 49">
            <a:extLst>
              <a:ext uri="{FF2B5EF4-FFF2-40B4-BE49-F238E27FC236}">
                <a16:creationId xmlns:a16="http://schemas.microsoft.com/office/drawing/2014/main" id="{D6E5F503-BD72-9558-4D4C-98EE03A5288B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909570" y="2766257"/>
            <a:ext cx="842387" cy="936000"/>
          </a:xfrm>
          <a:prstGeom prst="rect">
            <a:avLst/>
          </a:prstGeom>
        </p:spPr>
      </p:pic>
      <p:pic>
        <p:nvPicPr>
          <p:cNvPr id="52" name="Image 51">
            <a:extLst>
              <a:ext uri="{FF2B5EF4-FFF2-40B4-BE49-F238E27FC236}">
                <a16:creationId xmlns:a16="http://schemas.microsoft.com/office/drawing/2014/main" id="{07A134E5-8570-20C5-69BD-EF404DA9794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34522" y="2766257"/>
            <a:ext cx="848528" cy="936000"/>
          </a:xfrm>
          <a:prstGeom prst="rect">
            <a:avLst/>
          </a:prstGeom>
        </p:spPr>
      </p:pic>
      <p:sp>
        <p:nvSpPr>
          <p:cNvPr id="43" name="ZoneTexte 42">
            <a:extLst>
              <a:ext uri="{FF2B5EF4-FFF2-40B4-BE49-F238E27FC236}">
                <a16:creationId xmlns:a16="http://schemas.microsoft.com/office/drawing/2014/main" id="{72D043B6-ED61-8A18-20A9-F74E5D6964C8}"/>
              </a:ext>
            </a:extLst>
          </p:cNvPr>
          <p:cNvSpPr txBox="1"/>
          <p:nvPr/>
        </p:nvSpPr>
        <p:spPr>
          <a:xfrm>
            <a:off x="418808" y="4198199"/>
            <a:ext cx="620212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7. Pre-exposure to HTLV-1-infected T cells alters the transcriptional response of MDDCs to subsequent stimulation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is figure is relative to Fig. 4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capitulative table summarizing the different gene responsiveness patterns observed in the dataset (see Material and Methods for details). Genes were classified by comparing the DEG lists retrieved from the 3 comparisons indicated on the top of the table (criteria). A theoretical expression pattern across samples is illustrated in the right column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Seq2 normalized counts across samples of selected genes showing an “attenuated or abolished” (top), “conferred” (middle) or “unaffected” (bottom) responsiveness pattern. 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/>
          </a:p>
        </p:txBody>
      </p:sp>
      <p:sp>
        <p:nvSpPr>
          <p:cNvPr id="44" name="Espace réservé du numéro de diapositive 43">
            <a:extLst>
              <a:ext uri="{FF2B5EF4-FFF2-40B4-BE49-F238E27FC236}">
                <a16:creationId xmlns:a16="http://schemas.microsoft.com/office/drawing/2014/main" id="{88531CF5-D967-9F0B-8721-DB3F216D7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4003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3</TotalTime>
  <Words>435</Words>
  <Application>Microsoft Macintosh PowerPoint</Application>
  <PresentationFormat>Format A4 (210 x 297 mm)</PresentationFormat>
  <Paragraphs>96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7</cp:revision>
  <cp:lastPrinted>2024-05-03T15:39:09Z</cp:lastPrinted>
  <dcterms:created xsi:type="dcterms:W3CDTF">2023-02-24T13:22:32Z</dcterms:created>
  <dcterms:modified xsi:type="dcterms:W3CDTF">2024-05-06T10:12:55Z</dcterms:modified>
  <cp:category/>
</cp:coreProperties>
</file>